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7" r:id="rId2"/>
    <p:sldId id="271" r:id="rId3"/>
    <p:sldId id="27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096" autoAdjust="0"/>
  </p:normalViewPr>
  <p:slideViewPr>
    <p:cSldViewPr snapToGrid="0">
      <p:cViewPr varScale="1">
        <p:scale>
          <a:sx n="71" d="100"/>
          <a:sy n="71" d="100"/>
        </p:scale>
        <p:origin x="399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8CBE56-204B-4DE2-926B-9E185327A61D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441FA2-43CB-4627-A654-27E1C5B60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342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09F213-1CEF-2AE9-F94E-9B77293D0D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90C176C-665D-C805-8C30-8DA74DF7BF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450C39-C88F-6B59-7C48-45AE0C9F8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173366A-BD63-A8E8-DB16-001A7A357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10F587-5A39-FE7C-896F-433E98FA8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664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FC499C-8A6B-B90C-1B50-6D4EB5A2C3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D5D4067-5BB1-311E-72A7-6C5F02C71E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45AC33-4846-EC86-94BC-2A78150C8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72648C-1EC9-3676-C296-65EEE45AC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86E030-92DB-F7B0-A27E-F5CC7C519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3342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274D903-D71A-C9CF-B30A-C83F6CB16C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0FEDBCB-1692-89FD-2926-F16A601B8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492CDF-A60C-FBF5-498E-F3CBB83B6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C2BB9B-B61D-49AE-4951-9DF69E1B5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5EC572-F04C-821A-9D21-E21BD1A59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0390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3CE6D7-AD5D-69A9-7F07-2FE2AB32E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3AAC68-A94F-2D79-E38F-A08DF96B85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FA7FF6-6727-8EA6-289B-B6EFDED49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B1F8EA-C450-C314-52A4-EE247ACDE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38F28F-E1CB-2615-2258-0B19253C0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940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EFCE34-B251-6172-68F4-8D652BDF3F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C57A36-7D56-9A0A-7DDE-1281A8C7F1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1EE707-69C2-28F6-17D4-4ADF1CBA2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E4890B-9524-B6E7-92CD-B74B3ADDD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344454-D834-6B2B-C889-8AF35579F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4524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3258DB-D45B-A146-FCD2-0B34A2788E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8940ED-1959-1F47-B141-A52819D4CA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D10FDD-FC20-1860-1AC7-C18B9FB6D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25F4AE-43A4-1DAE-BB09-A5CAEEEF4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1DEACC-6856-CA0E-BE11-FCB7EFB90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8981C0D-2E5E-26BC-CB2A-72329E86D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445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7B0C3-DCF4-C379-5533-DD796B514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E80717A-4017-EDCF-C89B-DA9397A5BA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1AEB196-DF4C-4474-9286-25BDF8544A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3599E1A-3850-0C5E-A37E-13917B3CB9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F890766-D4C4-7928-23DF-1301BB6E66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62B7C10-7566-EE94-80F2-7ADEFC18A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197DFE1-7755-A08B-1C46-4CEACF4C9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6AEBCF3-C718-86DA-DE73-05FB47B19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403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8B27DE-15F4-8004-2E3F-3919C946DA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10BA54D-F67D-6B77-FAAF-CAA232BD2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8F7B4EF-0D67-1445-6DD2-DF482DB4F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865BE9B-DB21-8946-106E-B4F4DC11D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4799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42BA976-38E3-0D48-B103-DB873509A8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AC6D27C-B769-EB9D-CD7E-B0DFE2C5D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65CFAEE-12E5-2D65-B8E8-68FD3D897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847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28CF52-3C94-4A24-528B-BB56C3DC7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1A83D8-2FF7-122E-64AD-D4C4C70F13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B0A477-4079-4A4E-DD0C-B688083622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442B7C-51A6-1403-0C43-ED315E02F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937E36-7C82-1F16-629F-F6A5C8621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55C221-2657-A8DB-BE86-1846C96C0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5869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4F0059-49A8-A1DD-A514-A2B9F63D6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A5A3CD4-B5CC-BBC1-607A-0875481CFD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DA19448-22D5-21AB-38E2-8D0000C237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25FFA6-3036-7EF7-9C91-99E670223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2B5B4F-5B19-09E3-28F5-BEE0BD82D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5A795D-B9EA-7E10-6EBA-6903FEFB3D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680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584DE80-DACD-2AF5-791C-B5E059960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C39B3F0-F3D9-9BF0-A998-055548B24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6BC722-62F4-DDDC-167B-B0ED875440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E7A695-9470-4F0A-909A-D4071D84AA24}" type="datetimeFigureOut">
              <a:rPr lang="zh-CN" altLang="en-US" smtClean="0"/>
              <a:t>2026/4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E6CA69-F106-9E69-5A71-40ED8D65C6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847772-1C32-FCC2-41A9-06A55B8A01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AA819ED-5CCD-4211-9706-64B7EEB341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415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92035AFC-C6B2-2BC9-D9DB-AD57A819D6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4254" y="127023"/>
            <a:ext cx="8425166" cy="6624652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99767C55-343F-2F17-5DD2-14810055F2BF}"/>
              </a:ext>
            </a:extLst>
          </p:cNvPr>
          <p:cNvSpPr/>
          <p:nvPr/>
        </p:nvSpPr>
        <p:spPr>
          <a:xfrm>
            <a:off x="9123809" y="142475"/>
            <a:ext cx="2275609" cy="6323910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EC45544D-468F-A459-DEEC-C01271DCE781}"/>
              </a:ext>
            </a:extLst>
          </p:cNvPr>
          <p:cNvSpPr/>
          <p:nvPr/>
        </p:nvSpPr>
        <p:spPr>
          <a:xfrm>
            <a:off x="3763439" y="481741"/>
            <a:ext cx="7750244" cy="1756385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FEF6B83-179A-44DB-A54D-E81CB3342859}"/>
              </a:ext>
            </a:extLst>
          </p:cNvPr>
          <p:cNvCxnSpPr>
            <a:cxnSpLocks/>
          </p:cNvCxnSpPr>
          <p:nvPr/>
        </p:nvCxnSpPr>
        <p:spPr>
          <a:xfrm flipV="1">
            <a:off x="3774353" y="140269"/>
            <a:ext cx="8105067" cy="6325588"/>
          </a:xfrm>
          <a:prstGeom prst="line">
            <a:avLst/>
          </a:prstGeom>
          <a:ln>
            <a:solidFill>
              <a:schemeClr val="accent5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矩形 10">
            <a:extLst>
              <a:ext uri="{FF2B5EF4-FFF2-40B4-BE49-F238E27FC236}">
                <a16:creationId xmlns:a16="http://schemas.microsoft.com/office/drawing/2014/main" id="{05CC3FE6-7B87-AD83-1B4C-CFCD1ED526C7}"/>
              </a:ext>
            </a:extLst>
          </p:cNvPr>
          <p:cNvSpPr/>
          <p:nvPr/>
        </p:nvSpPr>
        <p:spPr>
          <a:xfrm>
            <a:off x="7179300" y="144154"/>
            <a:ext cx="1258915" cy="6323910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087E903D-867C-6B9C-C88F-CD66744EC308}"/>
              </a:ext>
            </a:extLst>
          </p:cNvPr>
          <p:cNvSpPr/>
          <p:nvPr/>
        </p:nvSpPr>
        <p:spPr>
          <a:xfrm>
            <a:off x="3757219" y="2830678"/>
            <a:ext cx="7750244" cy="957314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3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1AD874C-9CA4-2AF6-D817-849058580E23}"/>
              </a:ext>
            </a:extLst>
          </p:cNvPr>
          <p:cNvSpPr/>
          <p:nvPr/>
        </p:nvSpPr>
        <p:spPr>
          <a:xfrm>
            <a:off x="3788318" y="106325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76A40826-2547-A0C0-FEB6-EF07474D30F5}"/>
              </a:ext>
            </a:extLst>
          </p:cNvPr>
          <p:cNvSpPr/>
          <p:nvPr/>
        </p:nvSpPr>
        <p:spPr>
          <a:xfrm>
            <a:off x="11405954" y="142475"/>
            <a:ext cx="149909" cy="6323910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ED316202-DB8B-244B-ADCD-9C52092DC1B5}"/>
              </a:ext>
            </a:extLst>
          </p:cNvPr>
          <p:cNvSpPr/>
          <p:nvPr/>
        </p:nvSpPr>
        <p:spPr>
          <a:xfrm>
            <a:off x="3774355" y="2356532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846705B2-6E93-DBFD-688C-A3BAF5E4DCC5}"/>
              </a:ext>
            </a:extLst>
          </p:cNvPr>
          <p:cNvSpPr/>
          <p:nvPr/>
        </p:nvSpPr>
        <p:spPr>
          <a:xfrm>
            <a:off x="3758301" y="6017966"/>
            <a:ext cx="8121119" cy="440103"/>
          </a:xfrm>
          <a:prstGeom prst="rect">
            <a:avLst/>
          </a:prstGeom>
          <a:gradFill flip="none" rotWithShape="1">
            <a:gsLst>
              <a:gs pos="100000">
                <a:schemeClr val="accent5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Z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B165376-8387-B910-7725-FA3541106EB4}"/>
              </a:ext>
            </a:extLst>
          </p:cNvPr>
          <p:cNvSpPr/>
          <p:nvPr/>
        </p:nvSpPr>
        <p:spPr>
          <a:xfrm>
            <a:off x="3774353" y="106325"/>
            <a:ext cx="588721" cy="62808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DFE62B07-77F2-EC1E-2CF5-0585DF2341D6}"/>
              </a:ext>
            </a:extLst>
          </p:cNvPr>
          <p:cNvSpPr/>
          <p:nvPr/>
        </p:nvSpPr>
        <p:spPr>
          <a:xfrm>
            <a:off x="8438216" y="187187"/>
            <a:ext cx="669950" cy="62808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al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70930C23-FD54-C012-BE2F-19918ED1FAA0}"/>
              </a:ext>
            </a:extLst>
          </p:cNvPr>
          <p:cNvSpPr/>
          <p:nvPr/>
        </p:nvSpPr>
        <p:spPr>
          <a:xfrm>
            <a:off x="4344932" y="208280"/>
            <a:ext cx="2817688" cy="62575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9A0810D-8898-9BD6-F851-B6966DC10F3D}"/>
              </a:ext>
            </a:extLst>
          </p:cNvPr>
          <p:cNvSpPr/>
          <p:nvPr/>
        </p:nvSpPr>
        <p:spPr>
          <a:xfrm>
            <a:off x="3761913" y="3775548"/>
            <a:ext cx="7750244" cy="2266839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ABA0CCC6-FF41-CF71-BC2A-8696C79ED2BF}"/>
              </a:ext>
            </a:extLst>
          </p:cNvPr>
          <p:cNvSpPr/>
          <p:nvPr/>
        </p:nvSpPr>
        <p:spPr>
          <a:xfrm>
            <a:off x="3764201" y="2244344"/>
            <a:ext cx="7729296" cy="561453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Distal I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CB0D3BAF-4340-BDEF-B52F-D51C6F73510A}"/>
              </a:ext>
            </a:extLst>
          </p:cNvPr>
          <p:cNvSpPr/>
          <p:nvPr/>
        </p:nvSpPr>
        <p:spPr>
          <a:xfrm>
            <a:off x="3762675" y="374366"/>
            <a:ext cx="7743261" cy="105168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M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B973B14-D64D-7E46-561E-B72A7D97783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4748"/>
          <a:stretch>
            <a:fillRect/>
          </a:stretch>
        </p:blipFill>
        <p:spPr>
          <a:xfrm>
            <a:off x="91440" y="3115785"/>
            <a:ext cx="3316636" cy="208413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B8819AF-A402-1CBF-80CB-DE70C6E6AD08}"/>
              </a:ext>
            </a:extLst>
          </p:cNvPr>
          <p:cNvSpPr txBox="1"/>
          <p:nvPr/>
        </p:nvSpPr>
        <p:spPr>
          <a:xfrm>
            <a:off x="121801" y="374366"/>
            <a:ext cx="31724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 Enrichment of TTN Variants in Prenatal-Onset Recessive </a:t>
            </a:r>
            <a:r>
              <a:rPr lang="en-US" altLang="zh-CN" b="1" dirty="0" err="1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itinopathies</a:t>
            </a:r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Early</a:t>
            </a:r>
            <a:r>
              <a:rPr lang="zh-CN" alt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eath &amp; IUD Group (n=31)</a:t>
            </a:r>
            <a:endParaRPr lang="zh-CN" altLang="en-US" b="1" dirty="0">
              <a:solidFill>
                <a:srgbClr val="000000"/>
              </a:solidFill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8298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5764F00-CD2C-8E3C-8509-D0643EE479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0410" y="49996"/>
            <a:ext cx="8514430" cy="679498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074A1E0-0121-D2A5-E9DD-A0636E60952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4748"/>
          <a:stretch>
            <a:fillRect/>
          </a:stretch>
        </p:blipFill>
        <p:spPr>
          <a:xfrm>
            <a:off x="138094" y="3168666"/>
            <a:ext cx="3316636" cy="208413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644A464-306F-BBF5-9962-70483C5878D6}"/>
              </a:ext>
            </a:extLst>
          </p:cNvPr>
          <p:cNvSpPr txBox="1"/>
          <p:nvPr/>
        </p:nvSpPr>
        <p:spPr>
          <a:xfrm>
            <a:off x="133103" y="559027"/>
            <a:ext cx="326196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 Enrichment of TTN Variants in Prenatal-Onset Recessive </a:t>
            </a:r>
            <a:r>
              <a:rPr lang="en-US" altLang="zh-CN" b="1" dirty="0" err="1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itinopathies</a:t>
            </a:r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Respiratory Failure Group (n=27)</a:t>
            </a:r>
            <a:endParaRPr lang="zh-CN" altLang="en-US" b="1" dirty="0">
              <a:solidFill>
                <a:srgbClr val="000000"/>
              </a:solidFill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A23C658D-1822-6383-C273-3FAD3273DBB1}"/>
              </a:ext>
            </a:extLst>
          </p:cNvPr>
          <p:cNvSpPr/>
          <p:nvPr/>
        </p:nvSpPr>
        <p:spPr>
          <a:xfrm>
            <a:off x="9260028" y="226452"/>
            <a:ext cx="2271754" cy="6323910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D362B86-9A3C-F760-6B1F-0D6366149B9B}"/>
              </a:ext>
            </a:extLst>
          </p:cNvPr>
          <p:cNvSpPr/>
          <p:nvPr/>
        </p:nvSpPr>
        <p:spPr>
          <a:xfrm>
            <a:off x="3810093" y="398869"/>
            <a:ext cx="8042755" cy="1839258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F010EB7B-CBB9-DED4-E639-DD0EF1A1E6CC}"/>
              </a:ext>
            </a:extLst>
          </p:cNvPr>
          <p:cNvCxnSpPr>
            <a:cxnSpLocks/>
          </p:cNvCxnSpPr>
          <p:nvPr/>
        </p:nvCxnSpPr>
        <p:spPr>
          <a:xfrm flipV="1">
            <a:off x="3802346" y="199633"/>
            <a:ext cx="7955158" cy="6359532"/>
          </a:xfrm>
          <a:prstGeom prst="line">
            <a:avLst/>
          </a:prstGeom>
          <a:ln>
            <a:solidFill>
              <a:schemeClr val="accent5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矩形 11">
            <a:extLst>
              <a:ext uri="{FF2B5EF4-FFF2-40B4-BE49-F238E27FC236}">
                <a16:creationId xmlns:a16="http://schemas.microsoft.com/office/drawing/2014/main" id="{8920CCB5-B6AD-3E2B-3B78-5C17E7517448}"/>
              </a:ext>
            </a:extLst>
          </p:cNvPr>
          <p:cNvSpPr/>
          <p:nvPr/>
        </p:nvSpPr>
        <p:spPr>
          <a:xfrm>
            <a:off x="7253946" y="218800"/>
            <a:ext cx="1263447" cy="6323910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20729710-A0AF-DE02-30B3-320AD905869F}"/>
              </a:ext>
            </a:extLst>
          </p:cNvPr>
          <p:cNvSpPr/>
          <p:nvPr/>
        </p:nvSpPr>
        <p:spPr>
          <a:xfrm>
            <a:off x="3803873" y="2815221"/>
            <a:ext cx="8042755" cy="991431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3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B925440-0D86-2F72-5EEA-FB27EE8587A0}"/>
              </a:ext>
            </a:extLst>
          </p:cNvPr>
          <p:cNvSpPr/>
          <p:nvPr/>
        </p:nvSpPr>
        <p:spPr>
          <a:xfrm>
            <a:off x="3816311" y="199633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D258270-DC5F-CF26-062C-FF127A074279}"/>
              </a:ext>
            </a:extLst>
          </p:cNvPr>
          <p:cNvSpPr/>
          <p:nvPr/>
        </p:nvSpPr>
        <p:spPr>
          <a:xfrm>
            <a:off x="11527250" y="217121"/>
            <a:ext cx="149909" cy="6323910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973D7F5-BBA6-ED87-D6D2-325149FB89C9}"/>
              </a:ext>
            </a:extLst>
          </p:cNvPr>
          <p:cNvSpPr/>
          <p:nvPr/>
        </p:nvSpPr>
        <p:spPr>
          <a:xfrm>
            <a:off x="3802348" y="2449840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84629799-7F36-43FC-3BDF-6D5602863B69}"/>
              </a:ext>
            </a:extLst>
          </p:cNvPr>
          <p:cNvSpPr/>
          <p:nvPr/>
        </p:nvSpPr>
        <p:spPr>
          <a:xfrm>
            <a:off x="3795625" y="6098372"/>
            <a:ext cx="8121119" cy="451464"/>
          </a:xfrm>
          <a:prstGeom prst="rect">
            <a:avLst/>
          </a:prstGeom>
          <a:gradFill flip="none" rotWithShape="1">
            <a:gsLst>
              <a:gs pos="100000">
                <a:schemeClr val="accent5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Z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48E4A0E0-EF79-7A8C-C54C-A038A052B846}"/>
              </a:ext>
            </a:extLst>
          </p:cNvPr>
          <p:cNvSpPr/>
          <p:nvPr/>
        </p:nvSpPr>
        <p:spPr>
          <a:xfrm>
            <a:off x="3802346" y="199633"/>
            <a:ext cx="588721" cy="62808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9D8306A-7F7D-D94B-638D-A3F184A0833D}"/>
              </a:ext>
            </a:extLst>
          </p:cNvPr>
          <p:cNvSpPr/>
          <p:nvPr/>
        </p:nvSpPr>
        <p:spPr>
          <a:xfrm>
            <a:off x="8531523" y="261833"/>
            <a:ext cx="728504" cy="62808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al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34DBA99-FEE9-F005-9275-DDB4D308D5E0}"/>
              </a:ext>
            </a:extLst>
          </p:cNvPr>
          <p:cNvSpPr/>
          <p:nvPr/>
        </p:nvSpPr>
        <p:spPr>
          <a:xfrm>
            <a:off x="4372925" y="292257"/>
            <a:ext cx="2845341" cy="62575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A54C591A-D93C-F7BF-3096-F2F1A93F2F37}"/>
              </a:ext>
            </a:extLst>
          </p:cNvPr>
          <p:cNvSpPr/>
          <p:nvPr/>
        </p:nvSpPr>
        <p:spPr>
          <a:xfrm>
            <a:off x="3808568" y="3806652"/>
            <a:ext cx="7933908" cy="227305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928012A1-F922-70B4-82CB-EF07F3DD7BA2}"/>
              </a:ext>
            </a:extLst>
          </p:cNvPr>
          <p:cNvSpPr/>
          <p:nvPr/>
        </p:nvSpPr>
        <p:spPr>
          <a:xfrm>
            <a:off x="3820187" y="2244343"/>
            <a:ext cx="7729296" cy="561453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Distal I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A8D31314-6816-8086-D2A8-D5F37DCEAD40}"/>
              </a:ext>
            </a:extLst>
          </p:cNvPr>
          <p:cNvSpPr/>
          <p:nvPr/>
        </p:nvSpPr>
        <p:spPr>
          <a:xfrm>
            <a:off x="3799999" y="318379"/>
            <a:ext cx="7743261" cy="89820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M</a:t>
            </a:r>
          </a:p>
        </p:txBody>
      </p:sp>
    </p:spTree>
    <p:extLst>
      <p:ext uri="{BB962C8B-B14F-4D97-AF65-F5344CB8AC3E}">
        <p14:creationId xmlns:p14="http://schemas.microsoft.com/office/powerpoint/2010/main" val="24748399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7D16FA1-2F17-2150-F2AB-58EBD1DDFC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71975" y="0"/>
            <a:ext cx="7350976" cy="682813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5C15A71-FAF6-7B2F-B330-78779DA551C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4748"/>
          <a:stretch>
            <a:fillRect/>
          </a:stretch>
        </p:blipFill>
        <p:spPr>
          <a:xfrm>
            <a:off x="367364" y="3610949"/>
            <a:ext cx="3316636" cy="208413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A014107-A183-E05B-ECEF-7E3119213A4B}"/>
              </a:ext>
            </a:extLst>
          </p:cNvPr>
          <p:cNvSpPr txBox="1"/>
          <p:nvPr/>
        </p:nvSpPr>
        <p:spPr>
          <a:xfrm>
            <a:off x="145871" y="682145"/>
            <a:ext cx="362707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3 Enrichment of </a:t>
            </a:r>
            <a:r>
              <a:rPr lang="en-US" altLang="zh-CN" b="1" i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TN</a:t>
            </a:r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Variants in Prenatal-Onset Recessive </a:t>
            </a:r>
            <a:r>
              <a:rPr lang="en-US" altLang="zh-CN" b="1" dirty="0" err="1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itinopathies</a:t>
            </a:r>
            <a:r>
              <a:rPr lang="en-US" altLang="zh-CN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Cardiovascular Disease Group (n=14)</a:t>
            </a:r>
            <a:endParaRPr lang="zh-CN" altLang="en-US" b="1" dirty="0">
              <a:solidFill>
                <a:srgbClr val="000000"/>
              </a:solidFill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84294D63-AE67-F71A-E012-E305C10D0932}"/>
              </a:ext>
            </a:extLst>
          </p:cNvPr>
          <p:cNvSpPr/>
          <p:nvPr/>
        </p:nvSpPr>
        <p:spPr>
          <a:xfrm>
            <a:off x="9031078" y="200271"/>
            <a:ext cx="1951053" cy="6323910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F4C98B96-0982-8DE7-3362-B20A38D72217}"/>
              </a:ext>
            </a:extLst>
          </p:cNvPr>
          <p:cNvSpPr/>
          <p:nvPr/>
        </p:nvSpPr>
        <p:spPr>
          <a:xfrm>
            <a:off x="4380597" y="351571"/>
            <a:ext cx="7750244" cy="1836392"/>
          </a:xfrm>
          <a:prstGeom prst="rect">
            <a:avLst/>
          </a:prstGeom>
          <a:gradFill flip="none" rotWithShape="1">
            <a:gsLst>
              <a:gs pos="100000">
                <a:srgbClr val="FFFF00">
                  <a:alpha val="60000"/>
                </a:srgb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A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FD031E3B-3D34-E0A3-9522-855FF3CC6450}"/>
              </a:ext>
            </a:extLst>
          </p:cNvPr>
          <p:cNvCxnSpPr>
            <a:cxnSpLocks/>
          </p:cNvCxnSpPr>
          <p:nvPr/>
        </p:nvCxnSpPr>
        <p:spPr>
          <a:xfrm flipV="1">
            <a:off x="4362756" y="180574"/>
            <a:ext cx="6824648" cy="6361738"/>
          </a:xfrm>
          <a:prstGeom prst="line">
            <a:avLst/>
          </a:prstGeom>
          <a:ln>
            <a:solidFill>
              <a:schemeClr val="accent5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矩形 11">
            <a:extLst>
              <a:ext uri="{FF2B5EF4-FFF2-40B4-BE49-F238E27FC236}">
                <a16:creationId xmlns:a16="http://schemas.microsoft.com/office/drawing/2014/main" id="{9F7C96D2-34F3-3951-4872-F449FA565C15}"/>
              </a:ext>
            </a:extLst>
          </p:cNvPr>
          <p:cNvSpPr/>
          <p:nvPr/>
        </p:nvSpPr>
        <p:spPr>
          <a:xfrm>
            <a:off x="7329161" y="211278"/>
            <a:ext cx="1087051" cy="6323910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4BB9E56-2BFF-193D-FA8C-4AE33EE70CDC}"/>
              </a:ext>
            </a:extLst>
          </p:cNvPr>
          <p:cNvSpPr/>
          <p:nvPr/>
        </p:nvSpPr>
        <p:spPr>
          <a:xfrm>
            <a:off x="4373615" y="2765277"/>
            <a:ext cx="7750244" cy="1024522"/>
          </a:xfrm>
          <a:prstGeom prst="rect">
            <a:avLst/>
          </a:prstGeom>
          <a:gradFill flip="none" rotWithShape="1">
            <a:gsLst>
              <a:gs pos="100000">
                <a:schemeClr val="accent2">
                  <a:alpha val="60000"/>
                </a:schemeClr>
              </a:gs>
              <a:gs pos="3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-only</a:t>
            </a:r>
            <a:endParaRPr lang="zh-CN" altLang="en-US" sz="105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59C4CD4D-DC3D-30F9-C83F-5249251789D4}"/>
              </a:ext>
            </a:extLst>
          </p:cNvPr>
          <p:cNvSpPr/>
          <p:nvPr/>
        </p:nvSpPr>
        <p:spPr>
          <a:xfrm>
            <a:off x="4376721" y="182780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A89956D6-206A-3EDB-ACA3-A46CBB83EBD7}"/>
              </a:ext>
            </a:extLst>
          </p:cNvPr>
          <p:cNvSpPr/>
          <p:nvPr/>
        </p:nvSpPr>
        <p:spPr>
          <a:xfrm>
            <a:off x="10982132" y="201442"/>
            <a:ext cx="102636" cy="6323910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947BA6F4-E465-A2F1-2840-69ED6DF5AF9C}"/>
              </a:ext>
            </a:extLst>
          </p:cNvPr>
          <p:cNvSpPr/>
          <p:nvPr/>
        </p:nvSpPr>
        <p:spPr>
          <a:xfrm>
            <a:off x="4362758" y="2432987"/>
            <a:ext cx="7750244" cy="5056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8F7B9873-0904-14F5-6DF9-63AC10614560}"/>
              </a:ext>
            </a:extLst>
          </p:cNvPr>
          <p:cNvSpPr/>
          <p:nvPr/>
        </p:nvSpPr>
        <p:spPr>
          <a:xfrm>
            <a:off x="4376721" y="6089083"/>
            <a:ext cx="8121119" cy="440103"/>
          </a:xfrm>
          <a:prstGeom prst="rect">
            <a:avLst/>
          </a:prstGeom>
          <a:gradFill flip="none" rotWithShape="1">
            <a:gsLst>
              <a:gs pos="100000">
                <a:schemeClr val="accent5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Z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DB501CE-1A44-5D60-C829-49D3E940E9F0}"/>
              </a:ext>
            </a:extLst>
          </p:cNvPr>
          <p:cNvSpPr/>
          <p:nvPr/>
        </p:nvSpPr>
        <p:spPr>
          <a:xfrm>
            <a:off x="4362756" y="182780"/>
            <a:ext cx="588721" cy="62808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050" b="1" dirty="0">
              <a:solidFill>
                <a:schemeClr val="tx1"/>
              </a:solidFill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238DE0D-DEE2-E237-D59E-A1E2DE62A06B}"/>
              </a:ext>
            </a:extLst>
          </p:cNvPr>
          <p:cNvSpPr/>
          <p:nvPr/>
        </p:nvSpPr>
        <p:spPr>
          <a:xfrm>
            <a:off x="8420129" y="244980"/>
            <a:ext cx="593242" cy="62808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tal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C3D83A36-88FE-B0EB-4CF8-8C4E752A01B8}"/>
              </a:ext>
            </a:extLst>
          </p:cNvPr>
          <p:cNvSpPr/>
          <p:nvPr/>
        </p:nvSpPr>
        <p:spPr>
          <a:xfrm>
            <a:off x="4974774" y="275404"/>
            <a:ext cx="2331096" cy="6257577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altLang="zh-CN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D025DF6-7487-A2E4-BB6F-CB94F56F3FC8}"/>
              </a:ext>
            </a:extLst>
          </p:cNvPr>
          <p:cNvSpPr/>
          <p:nvPr/>
        </p:nvSpPr>
        <p:spPr>
          <a:xfrm>
            <a:off x="4386052" y="3789800"/>
            <a:ext cx="7750244" cy="2306408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I</a:t>
            </a:r>
            <a:endParaRPr lang="zh-CN" altLang="en-US" sz="105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1E2ED286-0622-A582-1603-DA0EC8C86658}"/>
              </a:ext>
            </a:extLst>
          </p:cNvPr>
          <p:cNvSpPr/>
          <p:nvPr/>
        </p:nvSpPr>
        <p:spPr>
          <a:xfrm>
            <a:off x="4380597" y="2190170"/>
            <a:ext cx="7729296" cy="561453"/>
          </a:xfrm>
          <a:prstGeom prst="rect">
            <a:avLst/>
          </a:prstGeom>
          <a:gradFill flip="none" rotWithShape="1">
            <a:gsLst>
              <a:gs pos="100000">
                <a:schemeClr val="accent6">
                  <a:lumMod val="20000"/>
                  <a:lumOff val="80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Distal I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E60E76E3-824A-2949-5B35-4D26696CA897}"/>
              </a:ext>
            </a:extLst>
          </p:cNvPr>
          <p:cNvSpPr/>
          <p:nvPr/>
        </p:nvSpPr>
        <p:spPr>
          <a:xfrm>
            <a:off x="4369740" y="249988"/>
            <a:ext cx="7743261" cy="113370"/>
          </a:xfrm>
          <a:prstGeom prst="rect">
            <a:avLst/>
          </a:prstGeom>
          <a:gradFill flip="none" rotWithShape="1">
            <a:gsLst>
              <a:gs pos="100000">
                <a:schemeClr val="tx1">
                  <a:lumMod val="50000"/>
                  <a:lumOff val="50000"/>
                  <a:alpha val="48000"/>
                </a:schemeClr>
              </a:gs>
              <a:gs pos="82000">
                <a:schemeClr val="bg1">
                  <a:alpha val="0"/>
                </a:scheme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M</a:t>
            </a:r>
          </a:p>
        </p:txBody>
      </p:sp>
    </p:spTree>
    <p:extLst>
      <p:ext uri="{BB962C8B-B14F-4D97-AF65-F5344CB8AC3E}">
        <p14:creationId xmlns:p14="http://schemas.microsoft.com/office/powerpoint/2010/main" val="1802679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107</Words>
  <Application>Microsoft Office PowerPoint</Application>
  <PresentationFormat>宽屏</PresentationFormat>
  <Paragraphs>57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 zheng</dc:creator>
  <cp:lastModifiedBy>yu zheng</cp:lastModifiedBy>
  <cp:revision>87</cp:revision>
  <dcterms:created xsi:type="dcterms:W3CDTF">2026-04-09T07:39:12Z</dcterms:created>
  <dcterms:modified xsi:type="dcterms:W3CDTF">2026-04-24T11:33:11Z</dcterms:modified>
</cp:coreProperties>
</file>